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8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19">
          <p15:clr>
            <a:srgbClr val="A4A3A4"/>
          </p15:clr>
        </p15:guide>
        <p15:guide id="2" pos="575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F7F7F"/>
    <a:srgbClr val="FFF799"/>
    <a:srgbClr val="FC633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18" d="100"/>
          <a:sy n="118" d="100"/>
        </p:scale>
        <p:origin x="1738" y="86"/>
      </p:cViewPr>
      <p:guideLst>
        <p:guide orient="horz" pos="4319"/>
        <p:guide pos="575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lee\Documents\My%20Dropbox\peer%20review%20papers\FDH\FDH%20qRTPCR%208-26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FDH</c:v>
          </c:tx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2-A337-4B71-8526-15628070F04F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3-A337-4B71-8526-15628070F04F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1-A337-4B71-8526-15628070F04F}"/>
              </c:ext>
            </c:extLst>
          </c:dPt>
          <c:errBars>
            <c:errBarType val="both"/>
            <c:errValType val="cust"/>
            <c:noEndCap val="0"/>
            <c:plus>
              <c:numRef>
                <c:f>FDH!$AA$23:$AA$25</c:f>
                <c:numCache>
                  <c:formatCode>General</c:formatCode>
                  <c:ptCount val="3"/>
                  <c:pt idx="0">
                    <c:v>3.1745011684071886E-2</c:v>
                  </c:pt>
                  <c:pt idx="1">
                    <c:v>0.1009074459441586</c:v>
                  </c:pt>
                  <c:pt idx="2">
                    <c:v>0.37952363665751149</c:v>
                  </c:pt>
                </c:numCache>
              </c:numRef>
            </c:plus>
            <c:minus>
              <c:numRef>
                <c:f>FDH!$AA$23:$AA$25</c:f>
                <c:numCache>
                  <c:formatCode>General</c:formatCode>
                  <c:ptCount val="3"/>
                  <c:pt idx="0">
                    <c:v>3.1745011684071886E-2</c:v>
                  </c:pt>
                  <c:pt idx="1">
                    <c:v>0.1009074459441586</c:v>
                  </c:pt>
                  <c:pt idx="2">
                    <c:v>0.37952363665751149</c:v>
                  </c:pt>
                </c:numCache>
              </c:numRef>
            </c:minus>
          </c:errBars>
          <c:cat>
            <c:strRef>
              <c:f>FDH!$I$15:$I$17</c:f>
              <c:strCache>
                <c:ptCount val="3"/>
                <c:pt idx="0">
                  <c:v>Water</c:v>
                </c:pt>
                <c:pt idx="1">
                  <c:v>Psm</c:v>
                </c:pt>
                <c:pt idx="2">
                  <c:v>Pstab</c:v>
                </c:pt>
              </c:strCache>
            </c:strRef>
          </c:cat>
          <c:val>
            <c:numRef>
              <c:f>FDH!$J$15:$J$17</c:f>
              <c:numCache>
                <c:formatCode>General</c:formatCode>
                <c:ptCount val="3"/>
                <c:pt idx="0">
                  <c:v>1</c:v>
                </c:pt>
                <c:pt idx="1">
                  <c:v>1.3104316884660172</c:v>
                </c:pt>
                <c:pt idx="2">
                  <c:v>2.05058051731367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337-4B71-8526-15628070F0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08005688"/>
        <c:axId val="308003336"/>
      </c:barChart>
      <c:catAx>
        <c:axId val="3080056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400">
                <a:solidFill>
                  <a:schemeClr val="bg1"/>
                </a:solidFill>
              </a:defRPr>
            </a:pPr>
            <a:endParaRPr lang="en-US"/>
          </a:p>
        </c:txPr>
        <c:crossAx val="308003336"/>
        <c:crosses val="autoZero"/>
        <c:auto val="1"/>
        <c:lblAlgn val="ctr"/>
        <c:lblOffset val="100"/>
        <c:noMultiLvlLbl val="0"/>
      </c:catAx>
      <c:valAx>
        <c:axId val="3080033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30800568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4F17D82-3F1F-41A1-912B-03A6EB64A52A}" type="datetimeFigureOut">
              <a:rPr lang="en-US" smtClean="0"/>
              <a:t>3/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639AA6-3582-4AB6-98DA-ECA16C4C0E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89956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07626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3205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5109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82472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27638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78370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59113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07111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8992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03708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57621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512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microsoft.com/office/2007/relationships/hdphoto" Target="../media/hdphoto1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 rot="16200000">
            <a:off x="562298" y="4252036"/>
            <a:ext cx="9252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Fold changes</a:t>
            </a:r>
          </a:p>
        </p:txBody>
      </p:sp>
      <p:graphicFrame>
        <p:nvGraphicFramePr>
          <p:cNvPr id="5" name="Chart 4"/>
          <p:cNvGraphicFramePr>
            <a:graphicFrameLocks/>
          </p:cNvGraphicFramePr>
          <p:nvPr/>
        </p:nvGraphicFramePr>
        <p:xfrm>
          <a:off x="1106274" y="3590048"/>
          <a:ext cx="2127409" cy="18381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633708" y="328524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890396D-C661-4E7A-8B58-3EAF0363E521}"/>
              </a:ext>
            </a:extLst>
          </p:cNvPr>
          <p:cNvSpPr txBox="1"/>
          <p:nvPr/>
        </p:nvSpPr>
        <p:spPr>
          <a:xfrm>
            <a:off x="2672344" y="3769087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**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1F3C7DF-33EE-4DC2-8854-A509F5FF538B}"/>
              </a:ext>
            </a:extLst>
          </p:cNvPr>
          <p:cNvSpPr txBox="1"/>
          <p:nvPr/>
        </p:nvSpPr>
        <p:spPr>
          <a:xfrm>
            <a:off x="2169978" y="4142903"/>
            <a:ext cx="2487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*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7C07125-3E2B-4948-A3EB-49F18F82FDDD}"/>
              </a:ext>
            </a:extLst>
          </p:cNvPr>
          <p:cNvSpPr txBox="1"/>
          <p:nvPr/>
        </p:nvSpPr>
        <p:spPr>
          <a:xfrm>
            <a:off x="670416" y="42522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533171" y="5036938"/>
            <a:ext cx="41389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/>
              <a:t>H</a:t>
            </a:r>
            <a:r>
              <a:rPr lang="en-US" sz="1100" baseline="-25000" dirty="0"/>
              <a:t>2</a:t>
            </a:r>
            <a:r>
              <a:rPr lang="en-US" sz="1100" dirty="0"/>
              <a:t>O</a:t>
            </a:r>
            <a:endParaRPr lang="en-US" sz="1100" baseline="-25000" dirty="0"/>
          </a:p>
        </p:txBody>
      </p:sp>
      <p:sp>
        <p:nvSpPr>
          <p:cNvPr id="20" name="TextBox 19"/>
          <p:cNvSpPr txBox="1"/>
          <p:nvPr/>
        </p:nvSpPr>
        <p:spPr>
          <a:xfrm>
            <a:off x="2070100" y="5036938"/>
            <a:ext cx="4235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i="1" dirty="0" err="1"/>
              <a:t>Psm</a:t>
            </a:r>
            <a:endParaRPr lang="en-US" sz="1100" i="1" baseline="-25000" dirty="0"/>
          </a:p>
        </p:txBody>
      </p:sp>
      <p:grpSp>
        <p:nvGrpSpPr>
          <p:cNvPr id="75" name="Group 74"/>
          <p:cNvGrpSpPr/>
          <p:nvPr/>
        </p:nvGrpSpPr>
        <p:grpSpPr>
          <a:xfrm>
            <a:off x="1106274" y="533400"/>
            <a:ext cx="6668510" cy="2751848"/>
            <a:chOff x="1106274" y="533400"/>
            <a:chExt cx="6668510" cy="2751848"/>
          </a:xfrm>
        </p:grpSpPr>
        <p:sp>
          <p:nvSpPr>
            <p:cNvPr id="6" name="TextBox 5"/>
            <p:cNvSpPr txBox="1"/>
            <p:nvPr/>
          </p:nvSpPr>
          <p:spPr>
            <a:xfrm>
              <a:off x="1193799" y="616043"/>
              <a:ext cx="2135079" cy="175433"/>
            </a:xfrm>
            <a:prstGeom prst="rect">
              <a:avLst/>
            </a:prstGeom>
            <a:solidFill>
              <a:srgbClr val="FC6330"/>
            </a:solidFill>
            <a:ln>
              <a:solidFill>
                <a:schemeClr val="accent6">
                  <a:lumMod val="50000"/>
                </a:schemeClr>
              </a:solidFill>
            </a:ln>
          </p:spPr>
          <p:txBody>
            <a:bodyPr wrap="square" lIns="0" tIns="18288" rIns="0" bIns="18288" rtlCol="0">
              <a:spAutoFit/>
            </a:bodyPr>
            <a:lstStyle/>
            <a:p>
              <a:pPr algn="ctr"/>
              <a:r>
                <a:rPr lang="en-US" sz="9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filtrating </a:t>
              </a:r>
              <a:r>
                <a:rPr lang="en-US" sz="900" b="1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seudomonas </a:t>
              </a:r>
              <a:r>
                <a:rPr lang="en-US" sz="900" b="1" i="1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yringae</a:t>
              </a:r>
              <a:endParaRPr lang="en-US" sz="900" b="1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6229125" y="3152693"/>
              <a:ext cx="1545659" cy="1140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tIns="9144" rIns="0" bIns="9144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Results provided by the </a:t>
              </a:r>
              <a:r>
                <a:rPr lang="en-U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Nümberger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 Lab</a:t>
              </a:r>
            </a:p>
          </p:txBody>
        </p:sp>
        <p:grpSp>
          <p:nvGrpSpPr>
            <p:cNvPr id="48" name="Group 47"/>
            <p:cNvGrpSpPr/>
            <p:nvPr/>
          </p:nvGrpSpPr>
          <p:grpSpPr>
            <a:xfrm>
              <a:off x="1371600" y="2376517"/>
              <a:ext cx="1047676" cy="780478"/>
              <a:chOff x="0" y="2571750"/>
              <a:chExt cx="1047676" cy="780478"/>
            </a:xfrm>
          </p:grpSpPr>
          <p:pic>
            <p:nvPicPr>
              <p:cNvPr id="33" name="Picture 32"/>
              <p:cNvPicPr>
                <a:picLocks noChangeAspect="1"/>
              </p:cNvPicPr>
              <p:nvPr/>
            </p:nvPicPr>
            <p:blipFill rotWithShape="1">
              <a:blip r:embed="rId3"/>
              <a:srcRect l="20594" t="19214" r="22043" b="21690"/>
              <a:stretch/>
            </p:blipFill>
            <p:spPr>
              <a:xfrm>
                <a:off x="92887" y="2798989"/>
                <a:ext cx="525576" cy="553239"/>
              </a:xfrm>
              <a:prstGeom prst="rect">
                <a:avLst/>
              </a:prstGeom>
            </p:spPr>
          </p:pic>
          <p:sp>
            <p:nvSpPr>
              <p:cNvPr id="34" name="TextBox 33"/>
              <p:cNvSpPr txBox="1"/>
              <p:nvPr/>
            </p:nvSpPr>
            <p:spPr>
              <a:xfrm>
                <a:off x="520626" y="3040906"/>
                <a:ext cx="527050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lIns="9144" tIns="0" rIns="9144" bIns="0" rtlCol="0">
                <a:spAutoFit/>
              </a:bodyPr>
              <a:lstStyle/>
              <a:p>
                <a:pPr algn="ctr"/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6 Hours </a:t>
                </a:r>
              </a:p>
              <a:p>
                <a:pPr algn="ctr"/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Sample</a:t>
                </a:r>
              </a:p>
            </p:txBody>
          </p:sp>
          <p:cxnSp>
            <p:nvCxnSpPr>
              <p:cNvPr id="36" name="Straight Connector 35"/>
              <p:cNvCxnSpPr/>
              <p:nvPr/>
            </p:nvCxnSpPr>
            <p:spPr>
              <a:xfrm>
                <a:off x="355675" y="2806700"/>
                <a:ext cx="0" cy="93331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TextBox 36"/>
              <p:cNvSpPr txBox="1"/>
              <p:nvPr/>
            </p:nvSpPr>
            <p:spPr>
              <a:xfrm>
                <a:off x="0" y="2571750"/>
                <a:ext cx="711351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lIns="9144" tIns="0" rIns="9144" bIns="0" rtlCol="0">
                <a:spAutoFit/>
              </a:bodyPr>
              <a:lstStyle/>
              <a:p>
                <a:pPr algn="ctr"/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INJECTION</a:t>
                </a:r>
              </a:p>
              <a:p>
                <a:pPr algn="ctr"/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24 Hour </a:t>
                </a:r>
              </a:p>
              <a:p>
                <a:pPr algn="ctr"/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Sample</a:t>
                </a:r>
              </a:p>
            </p:txBody>
          </p:sp>
          <p:cxnSp>
            <p:nvCxnSpPr>
              <p:cNvPr id="38" name="Straight Connector 37"/>
              <p:cNvCxnSpPr/>
              <p:nvPr/>
            </p:nvCxnSpPr>
            <p:spPr>
              <a:xfrm flipH="1">
                <a:off x="444500" y="2832100"/>
                <a:ext cx="79657" cy="80631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6" name="Group 45"/>
              <p:cNvGrpSpPr/>
              <p:nvPr/>
            </p:nvGrpSpPr>
            <p:grpSpPr>
              <a:xfrm>
                <a:off x="552450" y="3083490"/>
                <a:ext cx="91440" cy="0"/>
                <a:chOff x="711351" y="2438400"/>
                <a:chExt cx="91440" cy="0"/>
              </a:xfrm>
            </p:grpSpPr>
            <p:cxnSp>
              <p:nvCxnSpPr>
                <p:cNvPr id="44" name="Straight Connector 43"/>
                <p:cNvCxnSpPr/>
                <p:nvPr/>
              </p:nvCxnSpPr>
              <p:spPr>
                <a:xfrm>
                  <a:off x="711351" y="2438400"/>
                  <a:ext cx="9144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Straight Connector 44"/>
                <p:cNvCxnSpPr/>
                <p:nvPr/>
              </p:nvCxnSpPr>
              <p:spPr>
                <a:xfrm>
                  <a:off x="711351" y="2438400"/>
                  <a:ext cx="45720" cy="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7" name="TextBox 46"/>
              <p:cNvSpPr txBox="1"/>
              <p:nvPr/>
            </p:nvSpPr>
            <p:spPr>
              <a:xfrm>
                <a:off x="398498" y="2766969"/>
                <a:ext cx="527050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lIns="9144" tIns="0" rIns="9144" bIns="0" rtlCol="0">
                <a:spAutoFit/>
              </a:bodyPr>
              <a:lstStyle/>
              <a:p>
                <a:pPr algn="ctr"/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2 Hours </a:t>
                </a:r>
              </a:p>
              <a:p>
                <a:pPr algn="ctr"/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Sample</a:t>
                </a:r>
              </a:p>
            </p:txBody>
          </p:sp>
        </p:grpSp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ADACCEC4-15F7-4CF9-A6C1-ED2517B28F6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50000"/>
                      </a14:imgEffect>
                    </a14:imgLayer>
                  </a14:imgProps>
                </a:ext>
              </a:extLst>
            </a:blip>
            <a:srcRect l="552" t="10233" r="83978" b="31134"/>
            <a:stretch/>
          </p:blipFill>
          <p:spPr>
            <a:xfrm>
              <a:off x="1200150" y="838901"/>
              <a:ext cx="1066800" cy="1524000"/>
            </a:xfrm>
            <a:prstGeom prst="rect">
              <a:avLst/>
            </a:prstGeom>
            <a:ln>
              <a:noFill/>
            </a:ln>
          </p:spPr>
        </p:pic>
        <p:sp>
          <p:nvSpPr>
            <p:cNvPr id="56" name="Rectangle 55"/>
            <p:cNvSpPr/>
            <p:nvPr/>
          </p:nvSpPr>
          <p:spPr>
            <a:xfrm>
              <a:off x="1106274" y="533400"/>
              <a:ext cx="6666126" cy="275184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71" name="Group 70"/>
            <p:cNvGrpSpPr/>
            <p:nvPr/>
          </p:nvGrpSpPr>
          <p:grpSpPr>
            <a:xfrm>
              <a:off x="2590800" y="838200"/>
              <a:ext cx="2512092" cy="2400300"/>
              <a:chOff x="2590800" y="838200"/>
              <a:chExt cx="2512092" cy="2400300"/>
            </a:xfrm>
          </p:grpSpPr>
          <p:grpSp>
            <p:nvGrpSpPr>
              <p:cNvPr id="52" name="Group 51"/>
              <p:cNvGrpSpPr/>
              <p:nvPr/>
            </p:nvGrpSpPr>
            <p:grpSpPr>
              <a:xfrm>
                <a:off x="2590800" y="838200"/>
                <a:ext cx="2406650" cy="2286000"/>
                <a:chOff x="2286000" y="713561"/>
                <a:chExt cx="2406650" cy="2286000"/>
              </a:xfrm>
            </p:grpSpPr>
            <p:sp>
              <p:nvSpPr>
                <p:cNvPr id="7" name="TextBox 6"/>
                <p:cNvSpPr txBox="1"/>
                <p:nvPr/>
              </p:nvSpPr>
              <p:spPr>
                <a:xfrm>
                  <a:off x="2286000" y="901700"/>
                  <a:ext cx="711351" cy="203133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lIns="0" tIns="9144" rIns="0" bIns="9144" rtlCol="0">
                  <a:spAutoFit/>
                </a:bodyPr>
                <a:lstStyle/>
                <a:p>
                  <a:pPr algn="ctr"/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ock Treatment</a:t>
                  </a:r>
                </a:p>
                <a:p>
                  <a:pPr algn="ctr"/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10 </a:t>
                  </a:r>
                  <a:r>
                    <a:rPr lang="en-US" sz="6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M</a:t>
                  </a:r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MgCl2)</a:t>
                  </a:r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2286000" y="1678801"/>
                  <a:ext cx="711351" cy="276999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lIns="9144" tIns="0" rIns="9144" bIns="0" rtlCol="0">
                  <a:spAutoFit/>
                </a:bodyPr>
                <a:lstStyle/>
                <a:p>
                  <a:pPr algn="ctr"/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irulent</a:t>
                  </a:r>
                </a:p>
                <a:p>
                  <a:pPr algn="ctr"/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10e8 CFU / ml </a:t>
                  </a:r>
                  <a:r>
                    <a:rPr lang="en-US" sz="6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v</a:t>
                  </a:r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. </a:t>
                  </a:r>
                  <a:r>
                    <a:rPr lang="en-US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omato</a:t>
                  </a:r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DC3000)</a:t>
                  </a:r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2292350" y="2504301"/>
                  <a:ext cx="711351" cy="276999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lIns="9144" tIns="0" rIns="9144" bIns="0" rtlCol="0">
                  <a:spAutoFit/>
                </a:bodyPr>
                <a:lstStyle/>
                <a:p>
                  <a:pPr algn="ctr"/>
                  <a:r>
                    <a:rPr lang="en-US" sz="6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Avirulent</a:t>
                  </a:r>
                  <a:endParaRPr 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10e8 CFU / ml </a:t>
                  </a:r>
                  <a:r>
                    <a:rPr lang="en-US" sz="6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v</a:t>
                  </a:r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. </a:t>
                  </a:r>
                  <a:r>
                    <a:rPr lang="en-US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omato</a:t>
                  </a:r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avrRpm1)</a:t>
                  </a:r>
                </a:p>
              </p:txBody>
            </p:sp>
            <p:pic>
              <p:nvPicPr>
                <p:cNvPr id="50" name="Picture 49">
                  <a:extLst>
                    <a:ext uri="{FF2B5EF4-FFF2-40B4-BE49-F238E27FC236}">
                      <a16:creationId xmlns:a16="http://schemas.microsoft.com/office/drawing/2014/main" id="{ADACCEC4-15F7-4CF9-A6C1-ED2517B28F6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sharpenSoften amount="50000"/>
                          </a14:imgEffect>
                        </a14:imgLayer>
                      </a14:imgProps>
                    </a:ext>
                  </a:extLst>
                </a:blip>
                <a:srcRect l="27072" t="4462" r="49723" b="7589"/>
                <a:stretch/>
              </p:blipFill>
              <p:spPr>
                <a:xfrm>
                  <a:off x="3092450" y="713561"/>
                  <a:ext cx="1600200" cy="2286000"/>
                </a:xfrm>
                <a:prstGeom prst="rect">
                  <a:avLst/>
                </a:prstGeom>
                <a:ln>
                  <a:noFill/>
                </a:ln>
              </p:spPr>
            </p:pic>
          </p:grpSp>
          <p:grpSp>
            <p:nvGrpSpPr>
              <p:cNvPr id="60" name="Group 59"/>
              <p:cNvGrpSpPr/>
              <p:nvPr/>
            </p:nvGrpSpPr>
            <p:grpSpPr>
              <a:xfrm>
                <a:off x="3240033" y="3161556"/>
                <a:ext cx="1862859" cy="76944"/>
                <a:chOff x="3240033" y="3161556"/>
                <a:chExt cx="1862859" cy="76944"/>
              </a:xfrm>
            </p:grpSpPr>
            <p:sp>
              <p:nvSpPr>
                <p:cNvPr id="57" name="TextBox 56"/>
                <p:cNvSpPr txBox="1"/>
                <p:nvPr/>
              </p:nvSpPr>
              <p:spPr>
                <a:xfrm>
                  <a:off x="3905250" y="3161556"/>
                  <a:ext cx="527050" cy="769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lIns="9144" tIns="0" rIns="9144" bIns="0" rtlCol="0">
                  <a:spAutoFit/>
                </a:bodyPr>
                <a:lstStyle/>
                <a:p>
                  <a:pPr algn="ctr"/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 Hours</a:t>
                  </a:r>
                </a:p>
              </p:txBody>
            </p:sp>
            <p:sp>
              <p:nvSpPr>
                <p:cNvPr id="58" name="TextBox 57"/>
                <p:cNvSpPr txBox="1"/>
                <p:nvPr/>
              </p:nvSpPr>
              <p:spPr>
                <a:xfrm>
                  <a:off x="3240033" y="3161556"/>
                  <a:ext cx="527050" cy="769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lIns="9144" tIns="0" rIns="9144" bIns="0" rtlCol="0">
                  <a:spAutoFit/>
                </a:bodyPr>
                <a:lstStyle/>
                <a:p>
                  <a:pPr algn="ctr"/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 Hours</a:t>
                  </a:r>
                </a:p>
              </p:txBody>
            </p:sp>
            <p:sp>
              <p:nvSpPr>
                <p:cNvPr id="59" name="TextBox 58"/>
                <p:cNvSpPr txBox="1"/>
                <p:nvPr/>
              </p:nvSpPr>
              <p:spPr>
                <a:xfrm>
                  <a:off x="4575842" y="3161556"/>
                  <a:ext cx="527050" cy="769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lIns="9144" tIns="0" rIns="9144" bIns="0" rtlCol="0">
                  <a:spAutoFit/>
                </a:bodyPr>
                <a:lstStyle/>
                <a:p>
                  <a:pPr algn="ctr"/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4 Hours</a:t>
                  </a:r>
                </a:p>
              </p:txBody>
            </p:sp>
          </p:grpSp>
        </p:grpSp>
        <p:grpSp>
          <p:nvGrpSpPr>
            <p:cNvPr id="73" name="Group 72"/>
            <p:cNvGrpSpPr/>
            <p:nvPr/>
          </p:nvGrpSpPr>
          <p:grpSpPr>
            <a:xfrm>
              <a:off x="5206798" y="838200"/>
              <a:ext cx="2510761" cy="1574800"/>
              <a:chOff x="5206798" y="838200"/>
              <a:chExt cx="2510761" cy="1574800"/>
            </a:xfrm>
          </p:grpSpPr>
          <p:grpSp>
            <p:nvGrpSpPr>
              <p:cNvPr id="53" name="Group 52"/>
              <p:cNvGrpSpPr/>
              <p:nvPr/>
            </p:nvGrpSpPr>
            <p:grpSpPr>
              <a:xfrm>
                <a:off x="5206798" y="838200"/>
                <a:ext cx="2489402" cy="1476734"/>
                <a:chOff x="4946650" y="732611"/>
                <a:chExt cx="2489402" cy="1476734"/>
              </a:xfrm>
            </p:grpSpPr>
            <p:sp>
              <p:nvSpPr>
                <p:cNvPr id="24" name="TextBox 23"/>
                <p:cNvSpPr txBox="1"/>
                <p:nvPr/>
              </p:nvSpPr>
              <p:spPr>
                <a:xfrm>
                  <a:off x="4946650" y="810875"/>
                  <a:ext cx="711351" cy="461665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lIns="9144" tIns="0" rIns="9144" bIns="0" rtlCol="0">
                  <a:spAutoFit/>
                </a:bodyPr>
                <a:lstStyle/>
                <a:p>
                  <a:pPr algn="ctr"/>
                  <a:r>
                    <a:rPr lang="en-US" sz="6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ypelll</a:t>
                  </a:r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Secretion</a:t>
                  </a:r>
                </a:p>
                <a:p>
                  <a:pPr algn="ctr"/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ystem Deficient</a:t>
                  </a:r>
                </a:p>
                <a:p>
                  <a:pPr algn="ctr"/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10e8 CFU / ml </a:t>
                  </a:r>
                  <a:r>
                    <a:rPr lang="en-US" sz="6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v</a:t>
                  </a:r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. </a:t>
                  </a:r>
                  <a:r>
                    <a:rPr lang="en-US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omato</a:t>
                  </a:r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DC3000 </a:t>
                  </a:r>
                  <a:r>
                    <a:rPr lang="en-US" sz="6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hrcC</a:t>
                  </a:r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 )</a:t>
                  </a:r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4946650" y="1700212"/>
                  <a:ext cx="711351" cy="276999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lIns="9144" tIns="0" rIns="9144" bIns="0" rtlCol="0">
                  <a:spAutoFit/>
                </a:bodyPr>
                <a:lstStyle/>
                <a:p>
                  <a:pPr algn="ctr"/>
                  <a:r>
                    <a:rPr lang="en-US" sz="6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onhost</a:t>
                  </a:r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sz="6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Bacterua</a:t>
                  </a:r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10e8 CFU / ml </a:t>
                  </a:r>
                  <a:r>
                    <a:rPr lang="en-US" sz="6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v</a:t>
                  </a:r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. </a:t>
                  </a:r>
                  <a:r>
                    <a:rPr lang="en-US" sz="600" i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haseolicola</a:t>
                  </a:r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</a:p>
              </p:txBody>
            </p:sp>
            <p:pic>
              <p:nvPicPr>
                <p:cNvPr id="51" name="Picture 50">
                  <a:extLst>
                    <a:ext uri="{FF2B5EF4-FFF2-40B4-BE49-F238E27FC236}">
                      <a16:creationId xmlns:a16="http://schemas.microsoft.com/office/drawing/2014/main" id="{ADACCEC4-15F7-4CF9-A6C1-ED2517B28F6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sharpenSoften amount="50000"/>
                          </a14:imgEffect>
                        </a14:imgLayer>
                      </a14:imgProps>
                    </a:ext>
                  </a:extLst>
                </a:blip>
                <a:srcRect l="64641" t="36384" r="9666" b="6801"/>
                <a:stretch/>
              </p:blipFill>
              <p:spPr>
                <a:xfrm>
                  <a:off x="5664199" y="732611"/>
                  <a:ext cx="1771853" cy="1476734"/>
                </a:xfrm>
                <a:prstGeom prst="rect">
                  <a:avLst/>
                </a:prstGeom>
                <a:ln>
                  <a:noFill/>
                </a:ln>
              </p:spPr>
            </p:pic>
          </p:grpSp>
          <p:grpSp>
            <p:nvGrpSpPr>
              <p:cNvPr id="72" name="Group 71"/>
              <p:cNvGrpSpPr/>
              <p:nvPr/>
            </p:nvGrpSpPr>
            <p:grpSpPr>
              <a:xfrm>
                <a:off x="5842000" y="2336056"/>
                <a:ext cx="1875559" cy="76944"/>
                <a:chOff x="5842000" y="2336056"/>
                <a:chExt cx="1875559" cy="76944"/>
              </a:xfrm>
            </p:grpSpPr>
            <p:sp>
              <p:nvSpPr>
                <p:cNvPr id="68" name="TextBox 67"/>
                <p:cNvSpPr txBox="1"/>
                <p:nvPr/>
              </p:nvSpPr>
              <p:spPr>
                <a:xfrm>
                  <a:off x="6515100" y="2336056"/>
                  <a:ext cx="527050" cy="769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lIns="9144" tIns="0" rIns="9144" bIns="0" rtlCol="0">
                  <a:spAutoFit/>
                </a:bodyPr>
                <a:lstStyle/>
                <a:p>
                  <a:pPr algn="ctr"/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 Hours</a:t>
                  </a:r>
                </a:p>
              </p:txBody>
            </p:sp>
            <p:sp>
              <p:nvSpPr>
                <p:cNvPr id="69" name="TextBox 68"/>
                <p:cNvSpPr txBox="1"/>
                <p:nvPr/>
              </p:nvSpPr>
              <p:spPr>
                <a:xfrm>
                  <a:off x="5842000" y="2336056"/>
                  <a:ext cx="527050" cy="769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lIns="9144" tIns="0" rIns="9144" bIns="0" rtlCol="0">
                  <a:spAutoFit/>
                </a:bodyPr>
                <a:lstStyle/>
                <a:p>
                  <a:pPr algn="ctr"/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 Hours</a:t>
                  </a:r>
                </a:p>
              </p:txBody>
            </p:sp>
            <p:sp>
              <p:nvSpPr>
                <p:cNvPr id="70" name="TextBox 69"/>
                <p:cNvSpPr txBox="1"/>
                <p:nvPr/>
              </p:nvSpPr>
              <p:spPr>
                <a:xfrm>
                  <a:off x="7190509" y="2336056"/>
                  <a:ext cx="527050" cy="769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lIns="9144" tIns="0" rIns="9144" bIns="0" rtlCol="0">
                  <a:spAutoFit/>
                </a:bodyPr>
                <a:lstStyle/>
                <a:p>
                  <a:pPr algn="ctr"/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4 Hours</a:t>
                  </a:r>
                </a:p>
              </p:txBody>
            </p:sp>
          </p:grpSp>
        </p:grpSp>
      </p:grpSp>
      <p:sp>
        <p:nvSpPr>
          <p:cNvPr id="74" name="TextBox 73"/>
          <p:cNvSpPr txBox="1"/>
          <p:nvPr/>
        </p:nvSpPr>
        <p:spPr>
          <a:xfrm>
            <a:off x="2571440" y="5036938"/>
            <a:ext cx="4988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i="1" dirty="0" err="1"/>
              <a:t>Pstab</a:t>
            </a:r>
            <a:endParaRPr lang="en-US" sz="1100" i="1" baseline="-25000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E7DD21D-3C37-4619-B286-917ED21D0617}"/>
              </a:ext>
            </a:extLst>
          </p:cNvPr>
          <p:cNvSpPr txBox="1"/>
          <p:nvPr/>
        </p:nvSpPr>
        <p:spPr>
          <a:xfrm>
            <a:off x="1522933" y="3534264"/>
            <a:ext cx="5293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i="1" dirty="0"/>
              <a:t>FDH1</a:t>
            </a:r>
          </a:p>
        </p:txBody>
      </p:sp>
    </p:spTree>
    <p:extLst>
      <p:ext uri="{BB962C8B-B14F-4D97-AF65-F5344CB8AC3E}">
        <p14:creationId xmlns:p14="http://schemas.microsoft.com/office/powerpoint/2010/main" val="34681417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731</TotalTime>
  <Words>95</Words>
  <Application>Microsoft Office PowerPoint</Application>
  <PresentationFormat>On-screen Show (4:3)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oble Foundati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mrojas</dc:creator>
  <cp:lastModifiedBy>Lee,Seonghee</cp:lastModifiedBy>
  <cp:revision>136</cp:revision>
  <dcterms:created xsi:type="dcterms:W3CDTF">2012-05-31T18:29:42Z</dcterms:created>
  <dcterms:modified xsi:type="dcterms:W3CDTF">2022-03-06T21:48:00Z</dcterms:modified>
</cp:coreProperties>
</file>